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906000" type="A4"/>
  <p:notesSz cx="6858000" cy="914400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6" d="100"/>
          <a:sy n="76" d="100"/>
        </p:scale>
        <p:origin x="-3456" y="-11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E98F37-2336-4BE2-B376-E24C95E11207}" type="datetimeFigureOut">
              <a:rPr lang="en-GB" smtClean="0"/>
              <a:t>20/06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BBB79D-5202-415E-B281-307BE37FCB2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164354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E98F37-2336-4BE2-B376-E24C95E11207}" type="datetimeFigureOut">
              <a:rPr lang="en-GB" smtClean="0"/>
              <a:t>20/06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BBB79D-5202-415E-B281-307BE37FCB2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20406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E98F37-2336-4BE2-B376-E24C95E11207}" type="datetimeFigureOut">
              <a:rPr lang="en-GB" smtClean="0"/>
              <a:t>20/06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BBB79D-5202-415E-B281-307BE37FCB2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68677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E98F37-2336-4BE2-B376-E24C95E11207}" type="datetimeFigureOut">
              <a:rPr lang="en-GB" smtClean="0"/>
              <a:t>20/06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BBB79D-5202-415E-B281-307BE37FCB2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10327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E98F37-2336-4BE2-B376-E24C95E11207}" type="datetimeFigureOut">
              <a:rPr lang="en-GB" smtClean="0"/>
              <a:t>20/06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BBB79D-5202-415E-B281-307BE37FCB2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782755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E98F37-2336-4BE2-B376-E24C95E11207}" type="datetimeFigureOut">
              <a:rPr lang="en-GB" smtClean="0"/>
              <a:t>20/06/201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BBB79D-5202-415E-B281-307BE37FCB2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908741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E98F37-2336-4BE2-B376-E24C95E11207}" type="datetimeFigureOut">
              <a:rPr lang="en-GB" smtClean="0"/>
              <a:t>20/06/201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BBB79D-5202-415E-B281-307BE37FCB2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042339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E98F37-2336-4BE2-B376-E24C95E11207}" type="datetimeFigureOut">
              <a:rPr lang="en-GB" smtClean="0"/>
              <a:t>20/06/201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BBB79D-5202-415E-B281-307BE37FCB2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713462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E98F37-2336-4BE2-B376-E24C95E11207}" type="datetimeFigureOut">
              <a:rPr lang="en-GB" smtClean="0"/>
              <a:t>20/06/201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BBB79D-5202-415E-B281-307BE37FCB2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676446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E98F37-2336-4BE2-B376-E24C95E11207}" type="datetimeFigureOut">
              <a:rPr lang="en-GB" smtClean="0"/>
              <a:t>20/06/201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BBB79D-5202-415E-B281-307BE37FCB2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483846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E98F37-2336-4BE2-B376-E24C95E11207}" type="datetimeFigureOut">
              <a:rPr lang="en-GB" smtClean="0"/>
              <a:t>20/06/201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BBB79D-5202-415E-B281-307BE37FCB2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115732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E98F37-2336-4BE2-B376-E24C95E11207}" type="datetimeFigureOut">
              <a:rPr lang="en-GB" smtClean="0"/>
              <a:t>20/06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BBB79D-5202-415E-B281-307BE37FCB2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551556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551" t="15576" r="22009" b="11450"/>
          <a:stretch>
            <a:fillRect/>
          </a:stretch>
        </p:blipFill>
        <p:spPr bwMode="auto">
          <a:xfrm>
            <a:off x="765175" y="2505075"/>
            <a:ext cx="5105400" cy="43561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147" name="TextBox 4"/>
          <p:cNvSpPr txBox="1">
            <a:spLocks noChangeArrowheads="1"/>
          </p:cNvSpPr>
          <p:nvPr/>
        </p:nvSpPr>
        <p:spPr bwMode="auto">
          <a:xfrm>
            <a:off x="0" y="7257256"/>
            <a:ext cx="7042150" cy="9233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GB" dirty="0" smtClean="0"/>
              <a:t>Network of adhesion genes and ALP </a:t>
            </a:r>
            <a:r>
              <a:rPr lang="en-GB" dirty="0"/>
              <a:t>(ALPL</a:t>
            </a:r>
            <a:r>
              <a:rPr lang="en-GB" dirty="0" smtClean="0"/>
              <a:t>). </a:t>
            </a:r>
            <a:endParaRPr lang="en-GB" dirty="0"/>
          </a:p>
          <a:p>
            <a:pPr eaLnBrk="1" hangingPunct="1"/>
            <a:r>
              <a:rPr lang="en-GB" dirty="0" smtClean="0"/>
              <a:t>(</a:t>
            </a:r>
            <a:r>
              <a:rPr lang="en-GB" dirty="0" err="1" smtClean="0"/>
              <a:t>MetaCore</a:t>
            </a:r>
            <a:r>
              <a:rPr lang="en-GB" dirty="0" smtClean="0"/>
              <a:t>, shortest path algorithm, </a:t>
            </a:r>
            <a:r>
              <a:rPr lang="en-GB" dirty="0"/>
              <a:t>max 2 </a:t>
            </a:r>
            <a:r>
              <a:rPr lang="en-GB" dirty="0" smtClean="0"/>
              <a:t>steps)</a:t>
            </a:r>
            <a:endParaRPr lang="en-GB" dirty="0"/>
          </a:p>
          <a:p>
            <a:pPr eaLnBrk="1" hangingPunct="1"/>
            <a:r>
              <a:rPr lang="en-GB" dirty="0"/>
              <a:t>No connection between </a:t>
            </a:r>
            <a:r>
              <a:rPr lang="en-GB" dirty="0" err="1"/>
              <a:t>oxylipids</a:t>
            </a:r>
            <a:r>
              <a:rPr lang="en-GB" dirty="0"/>
              <a:t> and adhesion </a:t>
            </a:r>
            <a:r>
              <a:rPr lang="en-GB" dirty="0" smtClean="0"/>
              <a:t>genes</a:t>
            </a:r>
            <a:endParaRPr lang="en-GB" dirty="0"/>
          </a:p>
        </p:txBody>
      </p:sp>
      <p:sp>
        <p:nvSpPr>
          <p:cNvPr id="2" name="TextBox 1"/>
          <p:cNvSpPr txBox="1"/>
          <p:nvPr/>
        </p:nvSpPr>
        <p:spPr>
          <a:xfrm>
            <a:off x="332656" y="1064568"/>
            <a:ext cx="22391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Supplementary file 3. 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06311904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31</Words>
  <Application>Microsoft Office PowerPoint</Application>
  <PresentationFormat>A4 Paper (210x297 mm)</PresentationFormat>
  <Paragraphs>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TNO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jan van Erk</dc:creator>
  <cp:lastModifiedBy>Wilrike Pasman</cp:lastModifiedBy>
  <cp:revision>2</cp:revision>
  <dcterms:created xsi:type="dcterms:W3CDTF">2012-06-19T11:46:02Z</dcterms:created>
  <dcterms:modified xsi:type="dcterms:W3CDTF">2012-06-20T09:55:4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PresentationDate">
    <vt:lpwstr>19-6-2012 13:47:08</vt:lpwstr>
  </property>
</Properties>
</file>